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142" autoAdjust="0"/>
  </p:normalViewPr>
  <p:slideViewPr>
    <p:cSldViewPr snapToGrid="0">
      <p:cViewPr>
        <p:scale>
          <a:sx n="100" d="100"/>
          <a:sy n="100" d="100"/>
        </p:scale>
        <p:origin x="-1848" y="1908"/>
      </p:cViewPr>
      <p:guideLst>
        <p:guide orient="horz" pos="2880"/>
        <p:guide pos="3132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86B55A-1642-41A0-9291-C5CFD1A80D6A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DEB582-E75E-4700-9E01-481FCB63F0F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92238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49153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34608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6738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7747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84755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0261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44883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69213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1348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958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09958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19D8F-5631-42E2-B45D-2F495C29DD1C}" type="datetimeFigureOut">
              <a:rPr lang="de-CH" smtClean="0"/>
              <a:t>29.07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A13D6-E18B-41F6-81CB-F6B463D41AD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93072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74485" y="39237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84563" y="392374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0648" y="201936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70725" y="2019361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0648" y="3651312"/>
            <a:ext cx="5212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)&lt;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470726" y="3651312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60648" y="5246566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80251" y="5246566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0648" y="693686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470726" y="693686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)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601"/>
          <p:cNvSpPr txBox="1"/>
          <p:nvPr/>
        </p:nvSpPr>
        <p:spPr>
          <a:xfrm>
            <a:off x="4098774" y="8588517"/>
            <a:ext cx="2191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de-CH" sz="800" i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emofelis 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826" y="469596"/>
            <a:ext cx="2743910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825" y="2081881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0734" y="469596"/>
            <a:ext cx="2742996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0734" y="2081881"/>
            <a:ext cx="2742996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826" y="5375575"/>
            <a:ext cx="2743910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0735" y="5375575"/>
            <a:ext cx="2743910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Box 429"/>
          <p:cNvSpPr txBox="1"/>
          <p:nvPr/>
        </p:nvSpPr>
        <p:spPr>
          <a:xfrm rot="16200000">
            <a:off x="-131070" y="113878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 (g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29"/>
          <p:cNvSpPr txBox="1"/>
          <p:nvPr/>
        </p:nvSpPr>
        <p:spPr>
          <a:xfrm rot="16200000">
            <a:off x="-131070" y="2800302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lbumin (g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29"/>
          <p:cNvSpPr txBox="1"/>
          <p:nvPr/>
        </p:nvSpPr>
        <p:spPr>
          <a:xfrm rot="16200000">
            <a:off x="-131070" y="5946433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olesterol (mmol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29"/>
          <p:cNvSpPr txBox="1"/>
          <p:nvPr/>
        </p:nvSpPr>
        <p:spPr>
          <a:xfrm rot="16200000">
            <a:off x="3046594" y="113878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Protein (g/L)</a:t>
            </a:r>
          </a:p>
        </p:txBody>
      </p:sp>
      <p:sp>
        <p:nvSpPr>
          <p:cNvPr id="49" name="TextBox 429"/>
          <p:cNvSpPr txBox="1"/>
          <p:nvPr/>
        </p:nvSpPr>
        <p:spPr>
          <a:xfrm rot="16200000">
            <a:off x="3046594" y="2800302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lbumin 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(g/L)</a:t>
            </a:r>
          </a:p>
        </p:txBody>
      </p:sp>
      <p:sp>
        <p:nvSpPr>
          <p:cNvPr id="50" name="TextBox 429"/>
          <p:cNvSpPr txBox="1"/>
          <p:nvPr/>
        </p:nvSpPr>
        <p:spPr>
          <a:xfrm rot="16200000">
            <a:off x="3046594" y="5946433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olesterol 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(mmol/L)</a:t>
            </a:r>
          </a:p>
        </p:txBody>
      </p:sp>
      <p:cxnSp>
        <p:nvCxnSpPr>
          <p:cNvPr id="56" name="Straight Connector 55"/>
          <p:cNvCxnSpPr/>
          <p:nvPr/>
        </p:nvCxnSpPr>
        <p:spPr>
          <a:xfrm>
            <a:off x="1206194" y="2685312"/>
            <a:ext cx="347662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267561" y="252776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825" y="7001475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3" name="TextBox 429"/>
          <p:cNvSpPr txBox="1"/>
          <p:nvPr/>
        </p:nvSpPr>
        <p:spPr>
          <a:xfrm rot="16200000">
            <a:off x="-131070" y="759430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µ</a:t>
            </a:r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429"/>
          <p:cNvSpPr txBox="1"/>
          <p:nvPr/>
        </p:nvSpPr>
        <p:spPr>
          <a:xfrm rot="16200000">
            <a:off x="3046594" y="7594305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(µ</a:t>
            </a:r>
            <a:r>
              <a:rPr lang="de-CH" sz="800" dirty="0" err="1"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6857" y="7008737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6" name="TextBox 65"/>
          <p:cNvSpPr txBox="1"/>
          <p:nvPr/>
        </p:nvSpPr>
        <p:spPr>
          <a:xfrm>
            <a:off x="1067531" y="35175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258035" y="35175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67"/>
          <p:cNvCxnSpPr/>
          <p:nvPr/>
        </p:nvCxnSpPr>
        <p:spPr>
          <a:xfrm>
            <a:off x="1197749" y="5991863"/>
            <a:ext cx="347662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1259116" y="583431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104867" y="728174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455075" y="728174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609729" y="728174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757741" y="744368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>
            <a:off x="4484021" y="5934726"/>
            <a:ext cx="29607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4507725" y="576500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641672" y="248928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788304" y="73751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88"/>
          <p:cNvCxnSpPr/>
          <p:nvPr/>
        </p:nvCxnSpPr>
        <p:spPr>
          <a:xfrm>
            <a:off x="4007647" y="299004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4007647" y="2437633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795718" y="299004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795718" y="2437633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789368" y="156922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789368" y="94697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4007647" y="1566875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4007647" y="944617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786929" y="6518737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786929" y="6048878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4000886" y="6490297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4000886" y="6020438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4007647" y="8096846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4007647" y="746188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825029" y="8143689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825029" y="7508731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4610072" y="744843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281409" y="744365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825" y="3732180"/>
            <a:ext cx="2742996" cy="16458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0734" y="3731265"/>
            <a:ext cx="2742996" cy="1646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7" name="TextBox 429"/>
          <p:cNvSpPr txBox="1"/>
          <p:nvPr/>
        </p:nvSpPr>
        <p:spPr>
          <a:xfrm rot="16200000">
            <a:off x="-131070" y="4446931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obulin (g/L)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429"/>
          <p:cNvSpPr txBox="1"/>
          <p:nvPr/>
        </p:nvSpPr>
        <p:spPr>
          <a:xfrm rot="16200000">
            <a:off x="3046594" y="4446931"/>
            <a:ext cx="1286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obulin (g/L</a:t>
            </a:r>
            <a:r>
              <a:rPr lang="de-CH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9" name="Straight Connector 118"/>
          <p:cNvCxnSpPr/>
          <p:nvPr/>
        </p:nvCxnSpPr>
        <p:spPr>
          <a:xfrm>
            <a:off x="1189521" y="3852139"/>
            <a:ext cx="182735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1159861" y="368621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4794225" y="404662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Straight Connector 124"/>
          <p:cNvCxnSpPr/>
          <p:nvPr/>
        </p:nvCxnSpPr>
        <p:spPr>
          <a:xfrm>
            <a:off x="786929" y="5050615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789368" y="4455347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4000886" y="5046630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4016436" y="4465694"/>
            <a:ext cx="1872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601"/>
          <p:cNvSpPr txBox="1"/>
          <p:nvPr/>
        </p:nvSpPr>
        <p:spPr>
          <a:xfrm>
            <a:off x="894244" y="8588517"/>
            <a:ext cx="20394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de-CH" sz="800" i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CH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emofelis </a:t>
            </a:r>
            <a:r>
              <a:rPr lang="de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de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988772" y="576498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CH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556794" y="41365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97154" y="413651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up 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1773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</dc:creator>
  <cp:lastModifiedBy>Regina Hofmann</cp:lastModifiedBy>
  <cp:revision>216</cp:revision>
  <cp:lastPrinted>2015-04-09T09:13:44Z</cp:lastPrinted>
  <dcterms:created xsi:type="dcterms:W3CDTF">2013-01-23T18:37:05Z</dcterms:created>
  <dcterms:modified xsi:type="dcterms:W3CDTF">2015-07-29T11:44:37Z</dcterms:modified>
</cp:coreProperties>
</file>